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56" r:id="rId3"/>
    <p:sldId id="257" r:id="rId4"/>
    <p:sldId id="258" r:id="rId5"/>
    <p:sldId id="259" r:id="rId6"/>
    <p:sldId id="261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28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94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F18A9-0984-4E46-A51A-D0222E975A01}" type="datetimeFigureOut">
              <a:rPr kumimoji="1" lang="ja-JP" altLang="en-US" smtClean="0"/>
              <a:t>2026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88DFD-7672-45C6-9C6E-7FC751CED0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0031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F18A9-0984-4E46-A51A-D0222E975A01}" type="datetimeFigureOut">
              <a:rPr kumimoji="1" lang="ja-JP" altLang="en-US" smtClean="0"/>
              <a:t>2026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88DFD-7672-45C6-9C6E-7FC751CED0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46870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F18A9-0984-4E46-A51A-D0222E975A01}" type="datetimeFigureOut">
              <a:rPr kumimoji="1" lang="ja-JP" altLang="en-US" smtClean="0"/>
              <a:t>2026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88DFD-7672-45C6-9C6E-7FC751CED0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3278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F18A9-0984-4E46-A51A-D0222E975A01}" type="datetimeFigureOut">
              <a:rPr kumimoji="1" lang="ja-JP" altLang="en-US" smtClean="0"/>
              <a:t>2026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88DFD-7672-45C6-9C6E-7FC751CED0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29978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F18A9-0984-4E46-A51A-D0222E975A01}" type="datetimeFigureOut">
              <a:rPr kumimoji="1" lang="ja-JP" altLang="en-US" smtClean="0"/>
              <a:t>2026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88DFD-7672-45C6-9C6E-7FC751CED0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28567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F18A9-0984-4E46-A51A-D0222E975A01}" type="datetimeFigureOut">
              <a:rPr kumimoji="1" lang="ja-JP" altLang="en-US" smtClean="0"/>
              <a:t>2026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88DFD-7672-45C6-9C6E-7FC751CED0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8866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F18A9-0984-4E46-A51A-D0222E975A01}" type="datetimeFigureOut">
              <a:rPr kumimoji="1" lang="ja-JP" altLang="en-US" smtClean="0"/>
              <a:t>2026/2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88DFD-7672-45C6-9C6E-7FC751CED0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9502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F18A9-0984-4E46-A51A-D0222E975A01}" type="datetimeFigureOut">
              <a:rPr kumimoji="1" lang="ja-JP" altLang="en-US" smtClean="0"/>
              <a:t>2026/2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88DFD-7672-45C6-9C6E-7FC751CED0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1121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F18A9-0984-4E46-A51A-D0222E975A01}" type="datetimeFigureOut">
              <a:rPr kumimoji="1" lang="ja-JP" altLang="en-US" smtClean="0"/>
              <a:t>2026/2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88DFD-7672-45C6-9C6E-7FC751CED0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02502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F18A9-0984-4E46-A51A-D0222E975A01}" type="datetimeFigureOut">
              <a:rPr kumimoji="1" lang="ja-JP" altLang="en-US" smtClean="0"/>
              <a:t>2026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88DFD-7672-45C6-9C6E-7FC751CED0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71397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CF18A9-0984-4E46-A51A-D0222E975A01}" type="datetimeFigureOut">
              <a:rPr kumimoji="1" lang="ja-JP" altLang="en-US" smtClean="0"/>
              <a:t>2026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688DFD-7672-45C6-9C6E-7FC751CED0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9121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BCF18A9-0984-4E46-A51A-D0222E975A01}" type="datetimeFigureOut">
              <a:rPr kumimoji="1" lang="ja-JP" altLang="en-US" smtClean="0"/>
              <a:t>2026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5688DFD-7672-45C6-9C6E-7FC751CED0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8516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mp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D9200F9-B05B-4DF0-9DF7-B40965A276FE}"/>
              </a:ext>
            </a:extLst>
          </p:cNvPr>
          <p:cNvSpPr txBox="1"/>
          <p:nvPr/>
        </p:nvSpPr>
        <p:spPr>
          <a:xfrm>
            <a:off x="176818" y="1349081"/>
            <a:ext cx="8790364" cy="39292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ts val="2000"/>
              </a:lnSpc>
            </a:pPr>
            <a:r>
              <a:rPr lang="en-US" altLang="ja-JP" sz="1800" b="1" kern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</a:p>
          <a:p>
            <a:pPr>
              <a:lnSpc>
                <a:spcPts val="2000"/>
              </a:lnSpc>
            </a:pPr>
            <a:endParaRPr lang="en-US" altLang="ja-JP" b="1" kern="18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terologous Production of 2,2’-Dihydroxy Derivatives of Astaxanthin and Adonirubin in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cherichia coli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ja-JP" b="1">
                <a:latin typeface="Times New Roman" panose="02020603050405020304" pitchFamily="18" charset="0"/>
                <a:cs typeface="Times New Roman" panose="02020603050405020304" pitchFamily="18" charset="0"/>
              </a:rPr>
              <a:t>Evaluation of Their Antioxidant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b="1">
                <a:latin typeface="Times New Roman" panose="02020603050405020304" pitchFamily="18" charset="0"/>
                <a:cs typeface="Times New Roman" panose="02020603050405020304" pitchFamily="18" charset="0"/>
              </a:rPr>
              <a:t>ctivity</a:t>
            </a:r>
            <a:endParaRPr lang="ja-JP" altLang="ja-JP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ka Sekine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iho Takemura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isato Nagamori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orihiko Misawa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azutoshi Shindo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Department of Food and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trision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apan Women’s University, 2-8-1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jirodai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unkyo-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u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okyo 112-8681, Japan</a:t>
            </a:r>
          </a:p>
          <a:p>
            <a:pPr marL="342900" lvl="0" indent="-342900">
              <a:buAutoNum type="arabicPeriod"/>
            </a:pP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>
              <a:buAutoNum type="arabicPeriod"/>
            </a:pP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Research Institute for Bioresources and Biotechnology, Ishikawa Prefectural University, 1-308 Suematsu,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noichi-shi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21-8836, Japan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30193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 descr="鳥, 座る, 群れ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F11B82D0-87CE-5B7A-03AD-D1F5A26E2D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6835" y="1149405"/>
            <a:ext cx="8257710" cy="5168268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A5CD3FC-CE4A-A367-9CEE-872100353CDC}"/>
              </a:ext>
            </a:extLst>
          </p:cNvPr>
          <p:cNvSpPr txBox="1"/>
          <p:nvPr/>
        </p:nvSpPr>
        <p:spPr>
          <a:xfrm>
            <a:off x="369455" y="1932868"/>
            <a:ext cx="85601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</a:t>
            </a:r>
            <a:r>
              <a:rPr kumimoji="1"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H NMR spectrum of (2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3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2’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3’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2,2’-dihydroxyastaxanthhin (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CDCl</a:t>
            </a:r>
            <a:r>
              <a:rPr kumimoji="1" lang="en-US" altLang="ja-JP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97441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座る, 男, 立つ, 水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EE499FE2-925E-B552-99A5-B529A43A05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9054" y="666272"/>
            <a:ext cx="7351744" cy="5525455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6F8582F-023D-4F7F-194E-F0FD717778F8}"/>
              </a:ext>
            </a:extLst>
          </p:cNvPr>
          <p:cNvSpPr txBox="1"/>
          <p:nvPr/>
        </p:nvSpPr>
        <p:spPr>
          <a:xfrm>
            <a:off x="374876" y="296940"/>
            <a:ext cx="85601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 </a:t>
            </a:r>
            <a:r>
              <a:rPr kumimoji="1"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NMR spectrum of (2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3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2’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3’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2,2’-dihydroxyastaxanthhin (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CDCl</a:t>
            </a:r>
            <a:r>
              <a:rPr kumimoji="1" lang="en-US" altLang="ja-JP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72356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ダイアグラム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894198D3-7CE5-7435-E78E-8F438C2DE4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5209" y="861484"/>
            <a:ext cx="7826900" cy="5391534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19B49DB-3D49-DCA8-3FD2-A0659EDF5F1E}"/>
              </a:ext>
            </a:extLst>
          </p:cNvPr>
          <p:cNvSpPr txBox="1"/>
          <p:nvPr/>
        </p:nvSpPr>
        <p:spPr>
          <a:xfrm>
            <a:off x="735209" y="1304795"/>
            <a:ext cx="787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 </a:t>
            </a:r>
            <a:r>
              <a:rPr kumimoji="1"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H NMR spectrum of (2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3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2’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2,2’-dihydroxyadnirubin (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CDCl</a:t>
            </a:r>
            <a:r>
              <a:rPr kumimoji="1" lang="en-US" altLang="ja-JP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10350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座る, 大きい, 立つ, 男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06024973-4924-819B-6DFD-3CE60AAF56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8930" y="891814"/>
            <a:ext cx="7826532" cy="5730849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3144443-C81A-A447-F70D-7F890458EFAC}"/>
              </a:ext>
            </a:extLst>
          </p:cNvPr>
          <p:cNvSpPr txBox="1"/>
          <p:nvPr/>
        </p:nvSpPr>
        <p:spPr>
          <a:xfrm>
            <a:off x="788930" y="418104"/>
            <a:ext cx="79944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 </a:t>
            </a:r>
            <a:r>
              <a:rPr kumimoji="1"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NMR spectrum of (2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3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2’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2,2’-dihydroxyadnirubin (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CDCl</a:t>
            </a:r>
            <a:r>
              <a:rPr kumimoji="1" lang="en-US" altLang="ja-JP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13439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729D306-6F97-8A39-4E09-10D638AED97E}"/>
              </a:ext>
            </a:extLst>
          </p:cNvPr>
          <p:cNvSpPr txBox="1"/>
          <p:nvPr/>
        </p:nvSpPr>
        <p:spPr>
          <a:xfrm>
            <a:off x="96255" y="1245418"/>
            <a:ext cx="895148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 DPPH radical scavenging activities of </a:t>
            </a:r>
          </a:p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</a:t>
            </a:r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3</a:t>
            </a:r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2</a:t>
            </a:r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3’</a:t>
            </a:r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2,2’-dihydroxyastaxanthin (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(2</a:t>
            </a:r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3</a:t>
            </a:r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2’</a:t>
            </a:r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2,2’-dihydroxyadonirubin (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astaxanthin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 descr="グラフィカル ユーザー インターフェイス, アプリケーション, テーブル, Excel">
            <a:extLst>
              <a:ext uri="{FF2B5EF4-FFF2-40B4-BE49-F238E27FC236}">
                <a16:creationId xmlns:a16="http://schemas.microsoft.com/office/drawing/2014/main" id="{E25A7505-FD7D-BFFB-EA2C-F71885F104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06" t="35073" r="28295" b="18445"/>
          <a:stretch>
            <a:fillRect/>
          </a:stretch>
        </p:blipFill>
        <p:spPr>
          <a:xfrm>
            <a:off x="973103" y="2335072"/>
            <a:ext cx="6913704" cy="3941038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9715991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212</Words>
  <Application>Microsoft Office PowerPoint</Application>
  <PresentationFormat>画面に合わせる (4:3)</PresentationFormat>
  <Paragraphs>17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新藤 一敏</dc:creator>
  <cp:lastModifiedBy>新藤 一敏</cp:lastModifiedBy>
  <cp:revision>6</cp:revision>
  <dcterms:created xsi:type="dcterms:W3CDTF">2026-01-06T00:55:27Z</dcterms:created>
  <dcterms:modified xsi:type="dcterms:W3CDTF">2026-02-10T05:58:13Z</dcterms:modified>
</cp:coreProperties>
</file>